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94C472-25B2-4D24-8FF0-3B174CC7DDE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71B372-91CD-41BB-9BA4-8538035AE29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E1BB8-DEFE-4DAD-8542-24FD440461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13370-EF4F-4586-9B00-1F27471AA0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07E9C-14EA-4291-8E8C-3BD6E3E2C9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E2D53-A9A3-49F5-889A-6F55A20E4F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19D82-43E0-4471-82C8-5D6E32D5D8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E4763-A682-4EF6-AE49-236FBE1730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A3C44-1FD6-403D-8716-8BA6CA3EE8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2E257-4E0B-4062-B297-2C34F9AAE7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9F123-2901-4601-9741-972D18CB4C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844068-842B-40E0-A0D1-7CC627EBD1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88D52-A506-46BC-B008-821335AC5F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72883-93AD-4817-8832-84AF90D685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55F40B-4B06-4946-9C0B-FE83C591456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361800" y="1959120"/>
            <a:ext cx="8420400" cy="33750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668520" y="414360"/>
            <a:ext cx="7953480" cy="10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1 Monofunctional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Brachypodium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SDH ES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A)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rachypodium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ESTs are aligned to the predicte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rachypodium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nd the wheat LKR/SDH coding sequences. EST sequences matchi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ron 14 are shown in blue and green. Bases in green are the presumptive transcription initiation signal region. (B) Diagram of exon/intr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ganization of LKR/SDH bifunctional and SDH monofunctional transcripts. Exons are shown by boxes. The SDH first exon sequence 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ithin the LKR/SDH intron 14 and is shown by the blue box. The green box is the non-transcribed sequence indicated in frame A. Ex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mbers are given above (LKR/SDH) and below (SDH) exon box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5T04:09:38Z</dcterms:created>
  <dc:creator> </dc:creator>
  <dc:description/>
  <dc:language>en-US</dc:language>
  <cp:lastModifiedBy>Office 2003 Registered User</cp:lastModifiedBy>
  <dcterms:modified xsi:type="dcterms:W3CDTF">2010-05-18T22:50:45Z</dcterms:modified>
  <cp:revision>2</cp:revision>
  <dc:subject/>
  <dc:title>Slide 1</dc:title>
</cp:coreProperties>
</file>